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48"/>
  </p:normalViewPr>
  <p:slideViewPr>
    <p:cSldViewPr snapToGrid="0">
      <p:cViewPr>
        <p:scale>
          <a:sx n="98" d="100"/>
          <a:sy n="98" d="100"/>
        </p:scale>
        <p:origin x="-8" y="2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633CB0-5316-9D73-C3B4-7CED6709B6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6F985C2-BB3A-755E-621A-4871199364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2D3E44-6111-1C05-92B3-4DD1DA37E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EDD89-7F26-9741-A372-F575E1FDCDBF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0FB5A1-18AE-E854-1CDA-1B568E4869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5E33CF-7F8A-6D9D-AC96-7E7C5AE4A0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A88BE-1E42-7C44-B736-577D3C460A9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897711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E92781-6F4B-0A67-F911-D2AB3FF602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62D5A6-F441-4675-9526-D07EEB4D95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4F8232-9E60-09CD-8530-CC8EE35CC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EDD89-7F26-9741-A372-F575E1FDCDBF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8F11C1-B55A-67B3-D247-2B887A4D7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5EEE65-5055-5EE2-CDF2-E7B19609FC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A88BE-1E42-7C44-B736-577D3C460A9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10697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8349F18-0636-FC34-B25D-93D2B9805B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9C2D39-ECE0-0256-03BF-8C38494F09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72D5B5-5998-2C97-3B87-3AB9D1540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EDD89-7F26-9741-A372-F575E1FDCDBF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C6E8D0-35BE-4BF4-7579-15CDFE48A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8ED416-0821-2244-76AD-D7C203BC8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A88BE-1E42-7C44-B736-577D3C460A9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261375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C39C37-D612-9545-67D3-45107589B4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6384D7-AF44-B1C3-F827-9E1B579BEF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FA7B4A-879F-8063-FB7D-4BDCC8D2B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EDD89-7F26-9741-A372-F575E1FDCDBF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4A47BA-820E-CC29-2BF5-678C1A42A3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F0D7D8-BBB1-0CDD-D339-D381ACA01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A88BE-1E42-7C44-B736-577D3C460A9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824091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27A50E-FCDC-1FF7-B988-BD6E8B9C68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A2E953-AB60-DCC8-64F7-751FA65E8F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CB733D-B294-9AAF-C1EA-7EC6A00E0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EDD89-7F26-9741-A372-F575E1FDCDBF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B42BA2-AA84-7B51-4522-1197C6C46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14CA83-C7EB-B796-7D1E-FB8C3A5BC6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A88BE-1E42-7C44-B736-577D3C460A9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940384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5338BA-6194-B93B-D3D6-D80359E466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12EBFF-3D3B-16DA-35A3-FDC8BB2D0F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5F4B15-9EB8-4E0F-23C9-2E3C034F61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E00299-B4D1-E1D1-3385-F8613FD8A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EDD89-7F26-9741-A372-F575E1FDCDBF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F4269B-EE67-2208-42E2-6E824491C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C6E099-8AB2-9554-B644-7924BE2B8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A88BE-1E42-7C44-B736-577D3C460A9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489567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62C711-63B2-154B-2856-CEA8662F7E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C9AFBF-DE86-AA71-9287-03315181CF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F7D4B8-9A6D-6A9B-A9B1-FFE0B572C8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5533C07-56B7-BD07-B921-A9CD7A473B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10A8D2-97EA-8C63-1C02-1E65D10EEE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0886AF0-13B5-ACF1-1275-75EFE27C7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EDD89-7F26-9741-A372-F575E1FDCDBF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7082CDB-F3A1-040B-E250-E69C408443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2401E29-86BB-AC59-D426-F271914BB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A88BE-1E42-7C44-B736-577D3C460A9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939860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25E229-7478-95D0-25D9-44395D3E47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7BC8CBC-4A81-932B-B008-D3FDE00C5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EDD89-7F26-9741-A372-F575E1FDCDBF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77989B-7C7C-53D4-1E95-E21F6CD62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2A236C6-AD65-EFFC-204E-1AEE11A27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A88BE-1E42-7C44-B736-577D3C460A9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794933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1DB3B7-CB6B-302C-CD01-EC627FC31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EDD89-7F26-9741-A372-F575E1FDCDBF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1EAF9C5-3EB0-8892-64C7-C719174DED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B9FCC3-C04E-5881-F8A5-420D650331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A88BE-1E42-7C44-B736-577D3C460A9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078737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095C1A-1B7A-5B56-3EF3-DA405E5170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EB5733-B91F-3BEE-61B7-43A4005882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0DC0AF-77DC-F75D-7A2A-880C744D99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ED36D2-FE1E-7C9F-F4FB-84373AFE0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EDD89-7F26-9741-A372-F575E1FDCDBF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CFE0CE-00AD-0A96-8506-8DF73E4FF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A8BC9B-AFBF-8ACD-F05A-5E03635FC9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A88BE-1E42-7C44-B736-577D3C460A9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496304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B5F0E9-50D5-CE6E-A193-A004BBDD36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675875E-3F28-6E11-4A1D-03742BF889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A8AFEA-B617-9EDB-373A-90480516C7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A00595-46C4-34D1-C29D-FC93A25921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EDD89-7F26-9741-A372-F575E1FDCDBF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1BA652-C94D-0FFE-EC12-FD69CBDD9F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5BDE2F-BF52-43AC-DEA1-C101EE595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A88BE-1E42-7C44-B736-577D3C460A9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43035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A6DEED4-E7D5-47A2-D773-06709665DB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47A3F2-85F5-1727-6B82-A09E9B5049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F20791-1716-53BE-8855-4302206A6B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8EDD89-7F26-9741-A372-F575E1FDCDBF}" type="datetimeFigureOut">
              <a:rPr lang="en-VN" smtClean="0"/>
              <a:t>17/05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6E8CE7-4BE5-DD79-FA31-433638B368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DF14A6-2B26-553F-B461-F0D463E28F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3A88BE-1E42-7C44-B736-577D3C460A93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275938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E89DF2BF-12DB-B56D-1789-350CE6B2BE47}"/>
              </a:ext>
            </a:extLst>
          </p:cNvPr>
          <p:cNvSpPr/>
          <p:nvPr/>
        </p:nvSpPr>
        <p:spPr>
          <a:xfrm>
            <a:off x="2310638" y="138712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936C864-ABD4-7BBF-B5E2-6225EE9ECDC3}"/>
              </a:ext>
            </a:extLst>
          </p:cNvPr>
          <p:cNvSpPr/>
          <p:nvPr/>
        </p:nvSpPr>
        <p:spPr>
          <a:xfrm>
            <a:off x="3655367" y="140125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16733B8-C4F4-FBBD-413D-A242BB7338D9}"/>
              </a:ext>
            </a:extLst>
          </p:cNvPr>
          <p:cNvSpPr/>
          <p:nvPr/>
        </p:nvSpPr>
        <p:spPr>
          <a:xfrm>
            <a:off x="5621456" y="1370265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7EB2ABD-7022-958F-76F5-057EE31F03F6}"/>
              </a:ext>
            </a:extLst>
          </p:cNvPr>
          <p:cNvSpPr/>
          <p:nvPr/>
        </p:nvSpPr>
        <p:spPr>
          <a:xfrm>
            <a:off x="1047305" y="1387122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86FF636B-C8A6-5910-220D-C1830EA2DD8F}"/>
              </a:ext>
            </a:extLst>
          </p:cNvPr>
          <p:cNvCxnSpPr>
            <a:cxnSpLocks/>
          </p:cNvCxnSpPr>
          <p:nvPr/>
        </p:nvCxnSpPr>
        <p:spPr>
          <a:xfrm>
            <a:off x="1214897" y="1865058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096C83D7-A097-8835-15BC-A909F5539AC6}"/>
              </a:ext>
            </a:extLst>
          </p:cNvPr>
          <p:cNvSpPr txBox="1"/>
          <p:nvPr/>
        </p:nvSpPr>
        <p:spPr>
          <a:xfrm>
            <a:off x="310254" y="3685764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726E0B5-D35B-D204-29A3-C10E0A45730E}"/>
              </a:ext>
            </a:extLst>
          </p:cNvPr>
          <p:cNvSpPr txBox="1"/>
          <p:nvPr/>
        </p:nvSpPr>
        <p:spPr>
          <a:xfrm>
            <a:off x="300512" y="3130555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7D87E72-3D09-6512-429A-65C5C906E373}"/>
              </a:ext>
            </a:extLst>
          </p:cNvPr>
          <p:cNvSpPr/>
          <p:nvPr/>
        </p:nvSpPr>
        <p:spPr>
          <a:xfrm>
            <a:off x="2220416" y="1181816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0CF38F5-C330-9186-109A-53E4F70F16D8}"/>
              </a:ext>
            </a:extLst>
          </p:cNvPr>
          <p:cNvSpPr/>
          <p:nvPr/>
        </p:nvSpPr>
        <p:spPr>
          <a:xfrm>
            <a:off x="2710347" y="1238216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09048ED-8E75-39F9-DAC5-5EB5B565926A}"/>
              </a:ext>
            </a:extLst>
          </p:cNvPr>
          <p:cNvSpPr/>
          <p:nvPr/>
        </p:nvSpPr>
        <p:spPr>
          <a:xfrm>
            <a:off x="3228338" y="129331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1DBE561A-D7EC-6AD5-3881-4BDA2B9A0000}"/>
              </a:ext>
            </a:extLst>
          </p:cNvPr>
          <p:cNvSpPr/>
          <p:nvPr/>
        </p:nvSpPr>
        <p:spPr>
          <a:xfrm>
            <a:off x="3772091" y="129879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633A9F0C-41FB-60F9-D0AC-FDB83690D568}"/>
              </a:ext>
            </a:extLst>
          </p:cNvPr>
          <p:cNvSpPr/>
          <p:nvPr/>
        </p:nvSpPr>
        <p:spPr>
          <a:xfrm>
            <a:off x="4298527" y="1326383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49DABC55-5531-6E05-3F6C-4EDE9D934F4D}"/>
              </a:ext>
            </a:extLst>
          </p:cNvPr>
          <p:cNvSpPr/>
          <p:nvPr/>
        </p:nvSpPr>
        <p:spPr>
          <a:xfrm>
            <a:off x="1718126" y="1196235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DBC894B-E925-A2E9-B8CF-4529091C9527}"/>
              </a:ext>
            </a:extLst>
          </p:cNvPr>
          <p:cNvSpPr txBox="1"/>
          <p:nvPr/>
        </p:nvSpPr>
        <p:spPr>
          <a:xfrm>
            <a:off x="319995" y="289265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1504BF23-5F2C-3B53-B81D-8EDAA02BEFA7}"/>
              </a:ext>
            </a:extLst>
          </p:cNvPr>
          <p:cNvSpPr/>
          <p:nvPr/>
        </p:nvSpPr>
        <p:spPr>
          <a:xfrm>
            <a:off x="1883594" y="1220295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                     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C9F8EE9-9B44-839A-1809-C7FF364E6810}"/>
              </a:ext>
            </a:extLst>
          </p:cNvPr>
          <p:cNvSpPr txBox="1"/>
          <p:nvPr/>
        </p:nvSpPr>
        <p:spPr>
          <a:xfrm>
            <a:off x="791763" y="1945535"/>
            <a:ext cx="449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N   C   N    C   N   C    N    C   N    C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6F0A66F-9420-04B8-BB73-CFCD1A148823}"/>
              </a:ext>
            </a:extLst>
          </p:cNvPr>
          <p:cNvCxnSpPr>
            <a:cxnSpLocks/>
          </p:cNvCxnSpPr>
          <p:nvPr/>
        </p:nvCxnSpPr>
        <p:spPr>
          <a:xfrm>
            <a:off x="1170138" y="1486048"/>
            <a:ext cx="4360014" cy="1609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DA76E301-2782-CC20-C11E-69B0ADD34339}"/>
              </a:ext>
            </a:extLst>
          </p:cNvPr>
          <p:cNvSpPr/>
          <p:nvPr/>
        </p:nvSpPr>
        <p:spPr>
          <a:xfrm flipH="1">
            <a:off x="2729234" y="669868"/>
            <a:ext cx="60584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9795C2F1-C7B7-D5C5-6278-691109CB678F}"/>
              </a:ext>
            </a:extLst>
          </p:cNvPr>
          <p:cNvSpPr/>
          <p:nvPr/>
        </p:nvSpPr>
        <p:spPr>
          <a:xfrm>
            <a:off x="2615894" y="1621048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E5D5553A-E433-CF51-8556-84299E08D610}"/>
              </a:ext>
            </a:extLst>
          </p:cNvPr>
          <p:cNvSpPr/>
          <p:nvPr/>
        </p:nvSpPr>
        <p:spPr>
          <a:xfrm>
            <a:off x="3138561" y="1632187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7952C5CE-C28C-5E8F-5118-8CE2F07B2E79}"/>
              </a:ext>
            </a:extLst>
          </p:cNvPr>
          <p:cNvSpPr/>
          <p:nvPr/>
        </p:nvSpPr>
        <p:spPr>
          <a:xfrm>
            <a:off x="3618515" y="1518999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5F8D1258-EFB3-A50A-136C-6F1DDD2AE5F0}"/>
              </a:ext>
            </a:extLst>
          </p:cNvPr>
          <p:cNvSpPr/>
          <p:nvPr/>
        </p:nvSpPr>
        <p:spPr>
          <a:xfrm>
            <a:off x="4141422" y="1504493"/>
            <a:ext cx="82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81CB948B-56AF-B8FD-7562-21BB3BA8E654}"/>
              </a:ext>
            </a:extLst>
          </p:cNvPr>
          <p:cNvSpPr/>
          <p:nvPr/>
        </p:nvSpPr>
        <p:spPr>
          <a:xfrm>
            <a:off x="1587279" y="1612751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endParaRPr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0E70CC6B-4EC9-D5AD-0F32-18A5F50562AF}"/>
              </a:ext>
            </a:extLst>
          </p:cNvPr>
          <p:cNvSpPr/>
          <p:nvPr/>
        </p:nvSpPr>
        <p:spPr>
          <a:xfrm>
            <a:off x="2130861" y="1618004"/>
            <a:ext cx="82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endParaRPr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8A34E6D9-A3E3-8D6D-7AF4-CA1CEE6C87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5099" y="2239402"/>
            <a:ext cx="5280006" cy="2601423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92F908BE-C74C-49AB-567B-5988C82BCF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34202" y="2239402"/>
            <a:ext cx="5280007" cy="2601423"/>
          </a:xfrm>
          <a:prstGeom prst="rect">
            <a:avLst/>
          </a:prstGeom>
        </p:spPr>
      </p:pic>
      <p:sp>
        <p:nvSpPr>
          <p:cNvPr id="45" name="Rectangle 44">
            <a:extLst>
              <a:ext uri="{FF2B5EF4-FFF2-40B4-BE49-F238E27FC236}">
                <a16:creationId xmlns:a16="http://schemas.microsoft.com/office/drawing/2014/main" id="{A8A816F7-828D-EC46-7156-AF5E345B312A}"/>
              </a:ext>
            </a:extLst>
          </p:cNvPr>
          <p:cNvSpPr/>
          <p:nvPr/>
        </p:nvSpPr>
        <p:spPr>
          <a:xfrm>
            <a:off x="1078946" y="3095321"/>
            <a:ext cx="3795738" cy="26230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7EBBF40C-40A1-BA69-868E-85413424FD74}"/>
              </a:ext>
            </a:extLst>
          </p:cNvPr>
          <p:cNvSpPr/>
          <p:nvPr/>
        </p:nvSpPr>
        <p:spPr>
          <a:xfrm>
            <a:off x="1078946" y="3392924"/>
            <a:ext cx="3795738" cy="26230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B87756FF-47F3-5077-A60F-A0001B5544D0}"/>
              </a:ext>
            </a:extLst>
          </p:cNvPr>
          <p:cNvSpPr/>
          <p:nvPr/>
        </p:nvSpPr>
        <p:spPr>
          <a:xfrm>
            <a:off x="1137171" y="4262798"/>
            <a:ext cx="3795738" cy="26230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F3D6CD5-511D-BF6D-F54C-59456EF938F8}"/>
              </a:ext>
            </a:extLst>
          </p:cNvPr>
          <p:cNvSpPr txBox="1"/>
          <p:nvPr/>
        </p:nvSpPr>
        <p:spPr>
          <a:xfrm>
            <a:off x="4953696" y="4271643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278B320-B542-0344-F071-64FD34C3AF58}"/>
              </a:ext>
            </a:extLst>
          </p:cNvPr>
          <p:cNvSpPr txBox="1"/>
          <p:nvPr/>
        </p:nvSpPr>
        <p:spPr>
          <a:xfrm>
            <a:off x="4874684" y="3080623"/>
            <a:ext cx="1310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3A0319F-6651-A828-A838-9AF2AF2B1446}"/>
              </a:ext>
            </a:extLst>
          </p:cNvPr>
          <p:cNvSpPr txBox="1"/>
          <p:nvPr/>
        </p:nvSpPr>
        <p:spPr>
          <a:xfrm>
            <a:off x="4874683" y="3391036"/>
            <a:ext cx="1310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434F462-49CB-9B53-7610-E6FAE8BD7D77}"/>
              </a:ext>
            </a:extLst>
          </p:cNvPr>
          <p:cNvSpPr txBox="1"/>
          <p:nvPr/>
        </p:nvSpPr>
        <p:spPr>
          <a:xfrm>
            <a:off x="310254" y="3375660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AF65D8C-38CD-4129-2D3E-03F823C7956A}"/>
              </a:ext>
            </a:extLst>
          </p:cNvPr>
          <p:cNvSpPr txBox="1"/>
          <p:nvPr/>
        </p:nvSpPr>
        <p:spPr>
          <a:xfrm>
            <a:off x="271363" y="4255448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BBC4CF1-8DF0-F526-36CD-D50FD8F9049B}"/>
              </a:ext>
            </a:extLst>
          </p:cNvPr>
          <p:cNvSpPr txBox="1"/>
          <p:nvPr/>
        </p:nvSpPr>
        <p:spPr>
          <a:xfrm>
            <a:off x="300512" y="2548324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643F901-9FD7-EBB0-948B-7E45A26943B5}"/>
              </a:ext>
            </a:extLst>
          </p:cNvPr>
          <p:cNvSpPr txBox="1"/>
          <p:nvPr/>
        </p:nvSpPr>
        <p:spPr>
          <a:xfrm>
            <a:off x="267743" y="238782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0C4B012-C3C1-F48C-A8D8-37241F870AC4}"/>
              </a:ext>
            </a:extLst>
          </p:cNvPr>
          <p:cNvSpPr txBox="1"/>
          <p:nvPr/>
        </p:nvSpPr>
        <p:spPr>
          <a:xfrm>
            <a:off x="277402" y="2226715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592A0578-ED2C-DDEE-1F6A-8854A7253A6B}"/>
              </a:ext>
            </a:extLst>
          </p:cNvPr>
          <p:cNvSpPr/>
          <p:nvPr/>
        </p:nvSpPr>
        <p:spPr>
          <a:xfrm>
            <a:off x="6546275" y="2745306"/>
            <a:ext cx="3795738" cy="26230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26B4A4A-42AD-E1A2-E9DA-8567A5FE6570}"/>
              </a:ext>
            </a:extLst>
          </p:cNvPr>
          <p:cNvSpPr txBox="1"/>
          <p:nvPr/>
        </p:nvSpPr>
        <p:spPr>
          <a:xfrm>
            <a:off x="10362800" y="2754151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4358E0E-32F5-0F4C-B871-ED4B510E885C}"/>
              </a:ext>
            </a:extLst>
          </p:cNvPr>
          <p:cNvSpPr txBox="1"/>
          <p:nvPr/>
        </p:nvSpPr>
        <p:spPr>
          <a:xfrm>
            <a:off x="336952" y="427867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  <a:endParaRPr dirty="0"/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9BCB682B-3CE8-5756-3EC8-0B3145647727}"/>
              </a:ext>
            </a:extLst>
          </p:cNvPr>
          <p:cNvSpPr/>
          <p:nvPr/>
        </p:nvSpPr>
        <p:spPr>
          <a:xfrm>
            <a:off x="7754526" y="1403990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DE4D9079-1160-9AC8-23A6-BD12B0C48F10}"/>
              </a:ext>
            </a:extLst>
          </p:cNvPr>
          <p:cNvSpPr/>
          <p:nvPr/>
        </p:nvSpPr>
        <p:spPr>
          <a:xfrm>
            <a:off x="9099255" y="141812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ACC44BC1-0259-3BC3-653D-843C5E2AAF8F}"/>
              </a:ext>
            </a:extLst>
          </p:cNvPr>
          <p:cNvSpPr/>
          <p:nvPr/>
        </p:nvSpPr>
        <p:spPr>
          <a:xfrm>
            <a:off x="11065344" y="1387133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A99C9FA1-4777-16E2-8B8E-29A0FE99B242}"/>
              </a:ext>
            </a:extLst>
          </p:cNvPr>
          <p:cNvSpPr/>
          <p:nvPr/>
        </p:nvSpPr>
        <p:spPr>
          <a:xfrm>
            <a:off x="6491193" y="1403990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D71C1208-BBDF-4AF2-A0C9-921EC11BF810}"/>
              </a:ext>
            </a:extLst>
          </p:cNvPr>
          <p:cNvCxnSpPr>
            <a:cxnSpLocks/>
          </p:cNvCxnSpPr>
          <p:nvPr/>
        </p:nvCxnSpPr>
        <p:spPr>
          <a:xfrm>
            <a:off x="6658785" y="1881926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481A4AA2-C2F9-BF10-CA6B-D92CCBAF9CA0}"/>
              </a:ext>
            </a:extLst>
          </p:cNvPr>
          <p:cNvSpPr txBox="1"/>
          <p:nvPr/>
        </p:nvSpPr>
        <p:spPr>
          <a:xfrm>
            <a:off x="5754142" y="3702632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64DC4973-5419-0276-AD78-002F38DA4EED}"/>
              </a:ext>
            </a:extLst>
          </p:cNvPr>
          <p:cNvSpPr txBox="1"/>
          <p:nvPr/>
        </p:nvSpPr>
        <p:spPr>
          <a:xfrm>
            <a:off x="5744400" y="3147423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A571FC0E-505A-A7E5-B0D3-EE83DC57F935}"/>
              </a:ext>
            </a:extLst>
          </p:cNvPr>
          <p:cNvSpPr/>
          <p:nvPr/>
        </p:nvSpPr>
        <p:spPr>
          <a:xfrm>
            <a:off x="7664304" y="1198684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66553074-B285-1282-2168-07889FA406D4}"/>
              </a:ext>
            </a:extLst>
          </p:cNvPr>
          <p:cNvSpPr/>
          <p:nvPr/>
        </p:nvSpPr>
        <p:spPr>
          <a:xfrm>
            <a:off x="8154235" y="1255084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15DC6808-A6B0-2E85-2E1D-CAE84C09A924}"/>
              </a:ext>
            </a:extLst>
          </p:cNvPr>
          <p:cNvSpPr/>
          <p:nvPr/>
        </p:nvSpPr>
        <p:spPr>
          <a:xfrm>
            <a:off x="8672226" y="1310180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Rectangle 135">
            <a:extLst>
              <a:ext uri="{FF2B5EF4-FFF2-40B4-BE49-F238E27FC236}">
                <a16:creationId xmlns:a16="http://schemas.microsoft.com/office/drawing/2014/main" id="{E0C945D9-F869-1ABB-5C4B-AF236B521264}"/>
              </a:ext>
            </a:extLst>
          </p:cNvPr>
          <p:cNvSpPr/>
          <p:nvPr/>
        </p:nvSpPr>
        <p:spPr>
          <a:xfrm>
            <a:off x="9215979" y="1315660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Rectangle 136">
            <a:extLst>
              <a:ext uri="{FF2B5EF4-FFF2-40B4-BE49-F238E27FC236}">
                <a16:creationId xmlns:a16="http://schemas.microsoft.com/office/drawing/2014/main" id="{85D82CB2-A19E-5F38-0C7E-6CE1DC079A1F}"/>
              </a:ext>
            </a:extLst>
          </p:cNvPr>
          <p:cNvSpPr/>
          <p:nvPr/>
        </p:nvSpPr>
        <p:spPr>
          <a:xfrm>
            <a:off x="9742415" y="1343251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A76CCFCE-8406-7BB4-FA19-5CA16FBE9168}"/>
              </a:ext>
            </a:extLst>
          </p:cNvPr>
          <p:cNvSpPr/>
          <p:nvPr/>
        </p:nvSpPr>
        <p:spPr>
          <a:xfrm>
            <a:off x="7162014" y="1213103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30E54CF0-B4EA-3CCE-2A47-4A37FDDC3C4E}"/>
              </a:ext>
            </a:extLst>
          </p:cNvPr>
          <p:cNvSpPr txBox="1"/>
          <p:nvPr/>
        </p:nvSpPr>
        <p:spPr>
          <a:xfrm>
            <a:off x="5763883" y="2909519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FE515CF6-A400-4AD9-CD97-E5EA2FF2504C}"/>
              </a:ext>
            </a:extLst>
          </p:cNvPr>
          <p:cNvSpPr/>
          <p:nvPr/>
        </p:nvSpPr>
        <p:spPr>
          <a:xfrm>
            <a:off x="7327482" y="1237163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                     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685103BC-FC4A-9294-DFD1-69127D59716C}"/>
              </a:ext>
            </a:extLst>
          </p:cNvPr>
          <p:cNvSpPr txBox="1"/>
          <p:nvPr/>
        </p:nvSpPr>
        <p:spPr>
          <a:xfrm>
            <a:off x="6235651" y="1962403"/>
            <a:ext cx="449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N   C   N    C   N   C    N    C   N    C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EE5EB2F2-8D9F-7779-C0A9-0A03FAAC0C73}"/>
              </a:ext>
            </a:extLst>
          </p:cNvPr>
          <p:cNvCxnSpPr>
            <a:cxnSpLocks/>
          </p:cNvCxnSpPr>
          <p:nvPr/>
        </p:nvCxnSpPr>
        <p:spPr>
          <a:xfrm>
            <a:off x="6614026" y="1502916"/>
            <a:ext cx="4360014" cy="1609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Rectangle 142">
            <a:extLst>
              <a:ext uri="{FF2B5EF4-FFF2-40B4-BE49-F238E27FC236}">
                <a16:creationId xmlns:a16="http://schemas.microsoft.com/office/drawing/2014/main" id="{F94DEDA2-A65A-602D-5E5C-AAF1E8284049}"/>
              </a:ext>
            </a:extLst>
          </p:cNvPr>
          <p:cNvSpPr/>
          <p:nvPr/>
        </p:nvSpPr>
        <p:spPr>
          <a:xfrm flipH="1">
            <a:off x="8173122" y="686736"/>
            <a:ext cx="60584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A5EFA2D5-8D8E-74ED-4E6A-326DC35D814B}"/>
              </a:ext>
            </a:extLst>
          </p:cNvPr>
          <p:cNvSpPr/>
          <p:nvPr/>
        </p:nvSpPr>
        <p:spPr>
          <a:xfrm>
            <a:off x="8059782" y="1637916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99264148-7505-B5F3-FB33-C8CFB0418316}"/>
              </a:ext>
            </a:extLst>
          </p:cNvPr>
          <p:cNvSpPr/>
          <p:nvPr/>
        </p:nvSpPr>
        <p:spPr>
          <a:xfrm>
            <a:off x="8582449" y="1649055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146" name="Rectangle 145">
            <a:extLst>
              <a:ext uri="{FF2B5EF4-FFF2-40B4-BE49-F238E27FC236}">
                <a16:creationId xmlns:a16="http://schemas.microsoft.com/office/drawing/2014/main" id="{FDD88405-EEE3-EF1F-48B7-E566EF2E70AA}"/>
              </a:ext>
            </a:extLst>
          </p:cNvPr>
          <p:cNvSpPr/>
          <p:nvPr/>
        </p:nvSpPr>
        <p:spPr>
          <a:xfrm>
            <a:off x="9062403" y="1535867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1B1AB963-8E72-7376-FA70-3CD655B7E388}"/>
              </a:ext>
            </a:extLst>
          </p:cNvPr>
          <p:cNvSpPr/>
          <p:nvPr/>
        </p:nvSpPr>
        <p:spPr>
          <a:xfrm>
            <a:off x="9585310" y="1521361"/>
            <a:ext cx="82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6CFB2CDB-896A-C4CF-0C36-C223671A4B3F}"/>
              </a:ext>
            </a:extLst>
          </p:cNvPr>
          <p:cNvSpPr/>
          <p:nvPr/>
        </p:nvSpPr>
        <p:spPr>
          <a:xfrm>
            <a:off x="7031167" y="1629619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endParaRPr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Rectangle 148">
            <a:extLst>
              <a:ext uri="{FF2B5EF4-FFF2-40B4-BE49-F238E27FC236}">
                <a16:creationId xmlns:a16="http://schemas.microsoft.com/office/drawing/2014/main" id="{D27AE873-AD02-E3C6-1CE6-166E44EEFEEA}"/>
              </a:ext>
            </a:extLst>
          </p:cNvPr>
          <p:cNvSpPr/>
          <p:nvPr/>
        </p:nvSpPr>
        <p:spPr>
          <a:xfrm>
            <a:off x="7574749" y="1634872"/>
            <a:ext cx="82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endParaRPr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738CA440-C41C-1704-7B92-40B0DD4ED763}"/>
              </a:ext>
            </a:extLst>
          </p:cNvPr>
          <p:cNvSpPr txBox="1"/>
          <p:nvPr/>
        </p:nvSpPr>
        <p:spPr>
          <a:xfrm>
            <a:off x="5754142" y="3392528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03B893B0-56F8-AF61-19E1-8F60142205C7}"/>
              </a:ext>
            </a:extLst>
          </p:cNvPr>
          <p:cNvSpPr txBox="1"/>
          <p:nvPr/>
        </p:nvSpPr>
        <p:spPr>
          <a:xfrm>
            <a:off x="5715251" y="4272316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C70519DA-A797-05CB-D336-E105CD3347C5}"/>
              </a:ext>
            </a:extLst>
          </p:cNvPr>
          <p:cNvSpPr txBox="1"/>
          <p:nvPr/>
        </p:nvSpPr>
        <p:spPr>
          <a:xfrm>
            <a:off x="5744400" y="2565192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C8C11214-C38A-5D73-38C2-5D466239C6F6}"/>
              </a:ext>
            </a:extLst>
          </p:cNvPr>
          <p:cNvSpPr txBox="1"/>
          <p:nvPr/>
        </p:nvSpPr>
        <p:spPr>
          <a:xfrm>
            <a:off x="5711631" y="2404689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CA805A35-FF68-7636-1857-6E30EE1B5A2D}"/>
              </a:ext>
            </a:extLst>
          </p:cNvPr>
          <p:cNvSpPr txBox="1"/>
          <p:nvPr/>
        </p:nvSpPr>
        <p:spPr>
          <a:xfrm>
            <a:off x="5721290" y="2243583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11044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1" grpId="0"/>
      <p:bldP spid="48" grpId="0"/>
      <p:bldP spid="60" grpId="0"/>
      <p:bldP spid="141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C235CD3-B5AB-E58B-E25D-DD42E23B16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-240000">
            <a:off x="495004" y="2303309"/>
            <a:ext cx="5184932" cy="267365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3969B9B-2226-CD9E-C156-A1A2DF8918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-240000">
            <a:off x="5901421" y="2188284"/>
            <a:ext cx="5153408" cy="265739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4C972C0-313D-55BD-1045-5DDABA95698E}"/>
              </a:ext>
            </a:extLst>
          </p:cNvPr>
          <p:cNvSpPr/>
          <p:nvPr/>
        </p:nvSpPr>
        <p:spPr>
          <a:xfrm>
            <a:off x="2310638" y="138712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93E18194-050D-9B02-A32F-67C9EFBDA129}"/>
              </a:ext>
            </a:extLst>
          </p:cNvPr>
          <p:cNvSpPr/>
          <p:nvPr/>
        </p:nvSpPr>
        <p:spPr>
          <a:xfrm>
            <a:off x="3655367" y="140125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837E365-8F65-17C2-72DC-0FD6657608A6}"/>
              </a:ext>
            </a:extLst>
          </p:cNvPr>
          <p:cNvSpPr/>
          <p:nvPr/>
        </p:nvSpPr>
        <p:spPr>
          <a:xfrm>
            <a:off x="5621456" y="1370265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445497B-DA4A-D69C-29FD-E60C1DF901BB}"/>
              </a:ext>
            </a:extLst>
          </p:cNvPr>
          <p:cNvSpPr/>
          <p:nvPr/>
        </p:nvSpPr>
        <p:spPr>
          <a:xfrm>
            <a:off x="1047305" y="1387122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8000743F-090A-838F-20C0-EA82F43A3A5E}"/>
              </a:ext>
            </a:extLst>
          </p:cNvPr>
          <p:cNvCxnSpPr>
            <a:cxnSpLocks/>
          </p:cNvCxnSpPr>
          <p:nvPr/>
        </p:nvCxnSpPr>
        <p:spPr>
          <a:xfrm>
            <a:off x="1214897" y="1865058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BE5D0537-ECAA-3220-325A-AA6C028380FA}"/>
              </a:ext>
            </a:extLst>
          </p:cNvPr>
          <p:cNvSpPr txBox="1"/>
          <p:nvPr/>
        </p:nvSpPr>
        <p:spPr>
          <a:xfrm>
            <a:off x="310254" y="3581670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01D8179-4E37-F861-884C-112306574199}"/>
              </a:ext>
            </a:extLst>
          </p:cNvPr>
          <p:cNvSpPr txBox="1"/>
          <p:nvPr/>
        </p:nvSpPr>
        <p:spPr>
          <a:xfrm>
            <a:off x="300512" y="3130555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A303830-FA25-20FE-2665-9B1C744691A6}"/>
              </a:ext>
            </a:extLst>
          </p:cNvPr>
          <p:cNvSpPr/>
          <p:nvPr/>
        </p:nvSpPr>
        <p:spPr>
          <a:xfrm>
            <a:off x="2220416" y="1181816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F01E074-BC4E-1EA3-836A-D018106B15D4}"/>
              </a:ext>
            </a:extLst>
          </p:cNvPr>
          <p:cNvSpPr/>
          <p:nvPr/>
        </p:nvSpPr>
        <p:spPr>
          <a:xfrm>
            <a:off x="2710347" y="1238216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4A90A6A6-0E43-ADA3-6B18-59358ABFB7FE}"/>
              </a:ext>
            </a:extLst>
          </p:cNvPr>
          <p:cNvSpPr/>
          <p:nvPr/>
        </p:nvSpPr>
        <p:spPr>
          <a:xfrm>
            <a:off x="3228338" y="129331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C045200-24CF-161B-7AFC-FB4C9F67CC80}"/>
              </a:ext>
            </a:extLst>
          </p:cNvPr>
          <p:cNvSpPr/>
          <p:nvPr/>
        </p:nvSpPr>
        <p:spPr>
          <a:xfrm>
            <a:off x="3772091" y="129879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354A98B-CF95-B966-81E3-6826EF1CA996}"/>
              </a:ext>
            </a:extLst>
          </p:cNvPr>
          <p:cNvSpPr/>
          <p:nvPr/>
        </p:nvSpPr>
        <p:spPr>
          <a:xfrm>
            <a:off x="4298527" y="1326383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FAE9B8EF-5C20-0ECA-8493-699A30C96F24}"/>
              </a:ext>
            </a:extLst>
          </p:cNvPr>
          <p:cNvSpPr/>
          <p:nvPr/>
        </p:nvSpPr>
        <p:spPr>
          <a:xfrm>
            <a:off x="1718126" y="1196235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BC2BA68-9758-5355-AE70-6FF7FE3C2FE4}"/>
              </a:ext>
            </a:extLst>
          </p:cNvPr>
          <p:cNvSpPr txBox="1"/>
          <p:nvPr/>
        </p:nvSpPr>
        <p:spPr>
          <a:xfrm>
            <a:off x="319995" y="289265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FF12EA7C-7D78-7A25-01BC-C2F8C3EA07C1}"/>
              </a:ext>
            </a:extLst>
          </p:cNvPr>
          <p:cNvSpPr/>
          <p:nvPr/>
        </p:nvSpPr>
        <p:spPr>
          <a:xfrm>
            <a:off x="1883594" y="1220295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                     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C0EB05A-127D-D403-DECC-7DA246484006}"/>
              </a:ext>
            </a:extLst>
          </p:cNvPr>
          <p:cNvSpPr txBox="1"/>
          <p:nvPr/>
        </p:nvSpPr>
        <p:spPr>
          <a:xfrm>
            <a:off x="791763" y="1945535"/>
            <a:ext cx="449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N   C   N    C   N   C    N    C   N    C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C5518A1-F316-3914-5070-CEC9E2C73635}"/>
              </a:ext>
            </a:extLst>
          </p:cNvPr>
          <p:cNvCxnSpPr>
            <a:cxnSpLocks/>
          </p:cNvCxnSpPr>
          <p:nvPr/>
        </p:nvCxnSpPr>
        <p:spPr>
          <a:xfrm>
            <a:off x="1170138" y="1486048"/>
            <a:ext cx="4360014" cy="1609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FD9C5EF0-F93B-0E6C-7F4F-0161DDDC1EB7}"/>
              </a:ext>
            </a:extLst>
          </p:cNvPr>
          <p:cNvSpPr/>
          <p:nvPr/>
        </p:nvSpPr>
        <p:spPr>
          <a:xfrm flipH="1">
            <a:off x="2729234" y="669868"/>
            <a:ext cx="60584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6509BFFD-F145-154E-C9AD-97F434569C45}"/>
              </a:ext>
            </a:extLst>
          </p:cNvPr>
          <p:cNvSpPr/>
          <p:nvPr/>
        </p:nvSpPr>
        <p:spPr>
          <a:xfrm>
            <a:off x="2615894" y="1621048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193ABD72-6FE0-CB0A-1C41-8C1373C89511}"/>
              </a:ext>
            </a:extLst>
          </p:cNvPr>
          <p:cNvSpPr/>
          <p:nvPr/>
        </p:nvSpPr>
        <p:spPr>
          <a:xfrm>
            <a:off x="3138561" y="1632187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4196C53-5513-A87B-D6E3-6A17C147EB94}"/>
              </a:ext>
            </a:extLst>
          </p:cNvPr>
          <p:cNvSpPr/>
          <p:nvPr/>
        </p:nvSpPr>
        <p:spPr>
          <a:xfrm>
            <a:off x="3618515" y="1518999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F4382E65-5ED7-905C-E616-DFFBFEE5FD2C}"/>
              </a:ext>
            </a:extLst>
          </p:cNvPr>
          <p:cNvSpPr/>
          <p:nvPr/>
        </p:nvSpPr>
        <p:spPr>
          <a:xfrm>
            <a:off x="4141422" y="1504493"/>
            <a:ext cx="82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39F9933-01D0-02BA-697A-AA8E678F6B1A}"/>
              </a:ext>
            </a:extLst>
          </p:cNvPr>
          <p:cNvSpPr/>
          <p:nvPr/>
        </p:nvSpPr>
        <p:spPr>
          <a:xfrm>
            <a:off x="1587279" y="1612751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endParaRPr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C034D898-8A21-9723-52E0-F4700FDAA734}"/>
              </a:ext>
            </a:extLst>
          </p:cNvPr>
          <p:cNvSpPr/>
          <p:nvPr/>
        </p:nvSpPr>
        <p:spPr>
          <a:xfrm>
            <a:off x="2130861" y="1618004"/>
            <a:ext cx="82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endParaRPr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29C46ECD-592D-DD8C-899D-4982EC6F039C}"/>
              </a:ext>
            </a:extLst>
          </p:cNvPr>
          <p:cNvSpPr/>
          <p:nvPr/>
        </p:nvSpPr>
        <p:spPr>
          <a:xfrm>
            <a:off x="1078946" y="2909519"/>
            <a:ext cx="3795738" cy="34702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709E627C-576A-B4C7-BFA7-7A0DA9B47C8F}"/>
              </a:ext>
            </a:extLst>
          </p:cNvPr>
          <p:cNvSpPr/>
          <p:nvPr/>
        </p:nvSpPr>
        <p:spPr>
          <a:xfrm>
            <a:off x="1078946" y="3275330"/>
            <a:ext cx="3795738" cy="26230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DA4D3142-B811-EB30-B5EE-8303732A6225}"/>
              </a:ext>
            </a:extLst>
          </p:cNvPr>
          <p:cNvSpPr/>
          <p:nvPr/>
        </p:nvSpPr>
        <p:spPr>
          <a:xfrm>
            <a:off x="1151223" y="4099258"/>
            <a:ext cx="3795738" cy="26230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CC46B1C-E605-3169-828B-55E2612CE5C7}"/>
              </a:ext>
            </a:extLst>
          </p:cNvPr>
          <p:cNvSpPr txBox="1"/>
          <p:nvPr/>
        </p:nvSpPr>
        <p:spPr>
          <a:xfrm>
            <a:off x="4953696" y="4271643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4941961-DE08-BE20-87BB-7AEC6EBFFE4B}"/>
              </a:ext>
            </a:extLst>
          </p:cNvPr>
          <p:cNvSpPr txBox="1"/>
          <p:nvPr/>
        </p:nvSpPr>
        <p:spPr>
          <a:xfrm>
            <a:off x="4874684" y="3080623"/>
            <a:ext cx="1310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16D7CCD-49C1-7101-069E-EA61EA1ADFFF}"/>
              </a:ext>
            </a:extLst>
          </p:cNvPr>
          <p:cNvSpPr txBox="1"/>
          <p:nvPr/>
        </p:nvSpPr>
        <p:spPr>
          <a:xfrm>
            <a:off x="4874683" y="3391036"/>
            <a:ext cx="1310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6D44404-8F31-4146-7456-E7B3A75B8EA0}"/>
              </a:ext>
            </a:extLst>
          </p:cNvPr>
          <p:cNvSpPr txBox="1"/>
          <p:nvPr/>
        </p:nvSpPr>
        <p:spPr>
          <a:xfrm>
            <a:off x="310254" y="3375660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002F883-153C-ED2E-1776-BE6508F4C0E8}"/>
              </a:ext>
            </a:extLst>
          </p:cNvPr>
          <p:cNvSpPr txBox="1"/>
          <p:nvPr/>
        </p:nvSpPr>
        <p:spPr>
          <a:xfrm>
            <a:off x="298171" y="4004452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A9AD313-9AE6-7B6A-3C0F-55803D7F9115}"/>
              </a:ext>
            </a:extLst>
          </p:cNvPr>
          <p:cNvSpPr txBox="1"/>
          <p:nvPr/>
        </p:nvSpPr>
        <p:spPr>
          <a:xfrm>
            <a:off x="300512" y="2548324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1AB443B-1414-8FA8-6A1F-67A5DA60005B}"/>
              </a:ext>
            </a:extLst>
          </p:cNvPr>
          <p:cNvSpPr txBox="1"/>
          <p:nvPr/>
        </p:nvSpPr>
        <p:spPr>
          <a:xfrm>
            <a:off x="267743" y="238782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2019467-FA98-D9D0-1810-7828DA98E9FD}"/>
              </a:ext>
            </a:extLst>
          </p:cNvPr>
          <p:cNvSpPr txBox="1"/>
          <p:nvPr/>
        </p:nvSpPr>
        <p:spPr>
          <a:xfrm>
            <a:off x="277402" y="2226715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9301AA42-694D-FAC8-AFF2-8B54768359AC}"/>
              </a:ext>
            </a:extLst>
          </p:cNvPr>
          <p:cNvSpPr/>
          <p:nvPr/>
        </p:nvSpPr>
        <p:spPr>
          <a:xfrm>
            <a:off x="6547579" y="2614113"/>
            <a:ext cx="3795738" cy="26230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3148F76-6F48-FE14-E701-1191C922A380}"/>
              </a:ext>
            </a:extLst>
          </p:cNvPr>
          <p:cNvSpPr txBox="1"/>
          <p:nvPr/>
        </p:nvSpPr>
        <p:spPr>
          <a:xfrm>
            <a:off x="10362800" y="2754151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C3F7B36-AE42-403F-8B2C-85F829D53AF1}"/>
              </a:ext>
            </a:extLst>
          </p:cNvPr>
          <p:cNvSpPr txBox="1"/>
          <p:nvPr/>
        </p:nvSpPr>
        <p:spPr>
          <a:xfrm>
            <a:off x="336952" y="427867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  <a:endParaRPr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6F744DF9-6BE3-431A-A43C-10A498BB0281}"/>
              </a:ext>
            </a:extLst>
          </p:cNvPr>
          <p:cNvSpPr/>
          <p:nvPr/>
        </p:nvSpPr>
        <p:spPr>
          <a:xfrm>
            <a:off x="7754526" y="1403990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30218780-9DE2-DB13-8F0E-4A967538C9EA}"/>
              </a:ext>
            </a:extLst>
          </p:cNvPr>
          <p:cNvSpPr/>
          <p:nvPr/>
        </p:nvSpPr>
        <p:spPr>
          <a:xfrm>
            <a:off x="9099255" y="141812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8C8EF624-926A-FE2E-3C22-6BAEF3269975}"/>
              </a:ext>
            </a:extLst>
          </p:cNvPr>
          <p:cNvSpPr/>
          <p:nvPr/>
        </p:nvSpPr>
        <p:spPr>
          <a:xfrm>
            <a:off x="11065344" y="1387133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541BC05D-D7B4-E406-E106-1CEF862F4460}"/>
              </a:ext>
            </a:extLst>
          </p:cNvPr>
          <p:cNvSpPr/>
          <p:nvPr/>
        </p:nvSpPr>
        <p:spPr>
          <a:xfrm>
            <a:off x="6491193" y="1403990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366DC9B2-CCCB-F88D-664E-29515892BC1A}"/>
              </a:ext>
            </a:extLst>
          </p:cNvPr>
          <p:cNvCxnSpPr>
            <a:cxnSpLocks/>
          </p:cNvCxnSpPr>
          <p:nvPr/>
        </p:nvCxnSpPr>
        <p:spPr>
          <a:xfrm>
            <a:off x="6658785" y="1881926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D10D51D9-FEB5-8A97-BCB1-7C9287F41DF0}"/>
              </a:ext>
            </a:extLst>
          </p:cNvPr>
          <p:cNvSpPr txBox="1"/>
          <p:nvPr/>
        </p:nvSpPr>
        <p:spPr>
          <a:xfrm>
            <a:off x="5754142" y="3702632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A605DAB-65B3-D8D2-252D-727330FD204D}"/>
              </a:ext>
            </a:extLst>
          </p:cNvPr>
          <p:cNvSpPr txBox="1"/>
          <p:nvPr/>
        </p:nvSpPr>
        <p:spPr>
          <a:xfrm>
            <a:off x="5744400" y="3147423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E4B5829A-2E6C-3C09-0926-CD362E905E9E}"/>
              </a:ext>
            </a:extLst>
          </p:cNvPr>
          <p:cNvSpPr/>
          <p:nvPr/>
        </p:nvSpPr>
        <p:spPr>
          <a:xfrm>
            <a:off x="7664304" y="1198684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998C86D1-F8DF-A5FB-81BE-320558F52E5B}"/>
              </a:ext>
            </a:extLst>
          </p:cNvPr>
          <p:cNvSpPr/>
          <p:nvPr/>
        </p:nvSpPr>
        <p:spPr>
          <a:xfrm>
            <a:off x="8154235" y="1255084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AED7B921-9678-57BC-9838-ADD90F537FED}"/>
              </a:ext>
            </a:extLst>
          </p:cNvPr>
          <p:cNvSpPr/>
          <p:nvPr/>
        </p:nvSpPr>
        <p:spPr>
          <a:xfrm>
            <a:off x="8672226" y="1310180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9D6F9B16-E4DB-EC53-1397-D46F3BB83D5D}"/>
              </a:ext>
            </a:extLst>
          </p:cNvPr>
          <p:cNvSpPr/>
          <p:nvPr/>
        </p:nvSpPr>
        <p:spPr>
          <a:xfrm>
            <a:off x="9215979" y="1315660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D2566FF9-627E-7D21-2664-2201838558C9}"/>
              </a:ext>
            </a:extLst>
          </p:cNvPr>
          <p:cNvSpPr/>
          <p:nvPr/>
        </p:nvSpPr>
        <p:spPr>
          <a:xfrm>
            <a:off x="9742415" y="1343251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FBF4C89E-6819-C4AD-01C7-9FF90EC4804E}"/>
              </a:ext>
            </a:extLst>
          </p:cNvPr>
          <p:cNvSpPr/>
          <p:nvPr/>
        </p:nvSpPr>
        <p:spPr>
          <a:xfrm>
            <a:off x="7162014" y="1213103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BDE771B-1032-342A-41C8-D96B53D5EFAF}"/>
              </a:ext>
            </a:extLst>
          </p:cNvPr>
          <p:cNvSpPr txBox="1"/>
          <p:nvPr/>
        </p:nvSpPr>
        <p:spPr>
          <a:xfrm>
            <a:off x="5763883" y="2909519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0041DABA-4F49-ACEF-627C-67833A523111}"/>
              </a:ext>
            </a:extLst>
          </p:cNvPr>
          <p:cNvSpPr/>
          <p:nvPr/>
        </p:nvSpPr>
        <p:spPr>
          <a:xfrm>
            <a:off x="7327482" y="1237163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                     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4937C97-F70C-7750-DAD6-F9F7F68C1EF6}"/>
              </a:ext>
            </a:extLst>
          </p:cNvPr>
          <p:cNvSpPr txBox="1"/>
          <p:nvPr/>
        </p:nvSpPr>
        <p:spPr>
          <a:xfrm>
            <a:off x="6235651" y="1962403"/>
            <a:ext cx="449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N   C   N    C   N   C    N    C   N    C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0954D1B2-4AF5-91A2-6110-0E2B9705D4D1}"/>
              </a:ext>
            </a:extLst>
          </p:cNvPr>
          <p:cNvCxnSpPr>
            <a:cxnSpLocks/>
          </p:cNvCxnSpPr>
          <p:nvPr/>
        </p:nvCxnSpPr>
        <p:spPr>
          <a:xfrm>
            <a:off x="6614026" y="1502916"/>
            <a:ext cx="4360014" cy="1609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ectangle 62">
            <a:extLst>
              <a:ext uri="{FF2B5EF4-FFF2-40B4-BE49-F238E27FC236}">
                <a16:creationId xmlns:a16="http://schemas.microsoft.com/office/drawing/2014/main" id="{0C6E73CF-2223-A67F-EE57-1882A172148E}"/>
              </a:ext>
            </a:extLst>
          </p:cNvPr>
          <p:cNvSpPr/>
          <p:nvPr/>
        </p:nvSpPr>
        <p:spPr>
          <a:xfrm flipH="1">
            <a:off x="8173122" y="686736"/>
            <a:ext cx="60584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CA5FCE3C-8441-A50A-2E07-DC55D4818CDA}"/>
              </a:ext>
            </a:extLst>
          </p:cNvPr>
          <p:cNvSpPr/>
          <p:nvPr/>
        </p:nvSpPr>
        <p:spPr>
          <a:xfrm>
            <a:off x="8059782" y="1637916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336F2656-5CD4-19EA-9445-6D9C4C8BC115}"/>
              </a:ext>
            </a:extLst>
          </p:cNvPr>
          <p:cNvSpPr/>
          <p:nvPr/>
        </p:nvSpPr>
        <p:spPr>
          <a:xfrm>
            <a:off x="8582449" y="1649055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A01605F9-26F0-85D2-1BFE-D94A3AF246F9}"/>
              </a:ext>
            </a:extLst>
          </p:cNvPr>
          <p:cNvSpPr/>
          <p:nvPr/>
        </p:nvSpPr>
        <p:spPr>
          <a:xfrm>
            <a:off x="9062403" y="1535867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82D9D625-5BC7-661B-7462-D5C961F2F96B}"/>
              </a:ext>
            </a:extLst>
          </p:cNvPr>
          <p:cNvSpPr/>
          <p:nvPr/>
        </p:nvSpPr>
        <p:spPr>
          <a:xfrm>
            <a:off x="9585310" y="1521361"/>
            <a:ext cx="82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FAE5E448-5F1C-9DA5-8B8E-C7B377F8E345}"/>
              </a:ext>
            </a:extLst>
          </p:cNvPr>
          <p:cNvSpPr/>
          <p:nvPr/>
        </p:nvSpPr>
        <p:spPr>
          <a:xfrm>
            <a:off x="7031167" y="1629619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endParaRPr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3D3B1B0F-EC62-5CDE-92E1-EC956C3E02BD}"/>
              </a:ext>
            </a:extLst>
          </p:cNvPr>
          <p:cNvSpPr/>
          <p:nvPr/>
        </p:nvSpPr>
        <p:spPr>
          <a:xfrm>
            <a:off x="7574749" y="1634872"/>
            <a:ext cx="82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endParaRPr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A8181EC9-5036-0F1B-066E-08982EEDAF39}"/>
              </a:ext>
            </a:extLst>
          </p:cNvPr>
          <p:cNvSpPr txBox="1"/>
          <p:nvPr/>
        </p:nvSpPr>
        <p:spPr>
          <a:xfrm>
            <a:off x="5754142" y="3392528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F3126C5-A961-4E6A-B00B-B003B7C0A64F}"/>
              </a:ext>
            </a:extLst>
          </p:cNvPr>
          <p:cNvSpPr txBox="1"/>
          <p:nvPr/>
        </p:nvSpPr>
        <p:spPr>
          <a:xfrm>
            <a:off x="5715251" y="4272316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C71126B-B240-82AB-63D8-876125607AB1}"/>
              </a:ext>
            </a:extLst>
          </p:cNvPr>
          <p:cNvSpPr txBox="1"/>
          <p:nvPr/>
        </p:nvSpPr>
        <p:spPr>
          <a:xfrm>
            <a:off x="5744400" y="2565192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7C12A06-2478-5B47-2D73-B4236F6979E3}"/>
              </a:ext>
            </a:extLst>
          </p:cNvPr>
          <p:cNvSpPr txBox="1"/>
          <p:nvPr/>
        </p:nvSpPr>
        <p:spPr>
          <a:xfrm>
            <a:off x="5711631" y="2404689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C88F46F-80B0-8832-FE9E-0334539DFAC3}"/>
              </a:ext>
            </a:extLst>
          </p:cNvPr>
          <p:cNvSpPr txBox="1"/>
          <p:nvPr/>
        </p:nvSpPr>
        <p:spPr>
          <a:xfrm>
            <a:off x="5721290" y="2243583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46709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1" grpId="0"/>
      <p:bldP spid="35" grpId="0"/>
      <p:bldP spid="44" grpId="0"/>
      <p:bldP spid="61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4636A743-FFBF-5647-D150-3F56A5A277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4876" y="2271968"/>
            <a:ext cx="4800057" cy="252053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162124AC-FCC7-D902-143E-54C30D823D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05189" y="2283964"/>
            <a:ext cx="4535865" cy="2443117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881D7EC1-C6E3-A916-8CE2-85DEC19B21F0}"/>
              </a:ext>
            </a:extLst>
          </p:cNvPr>
          <p:cNvSpPr/>
          <p:nvPr/>
        </p:nvSpPr>
        <p:spPr>
          <a:xfrm>
            <a:off x="2310638" y="138712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B849F6B7-80DB-0F95-4D7C-9F576E9B79B5}"/>
              </a:ext>
            </a:extLst>
          </p:cNvPr>
          <p:cNvSpPr/>
          <p:nvPr/>
        </p:nvSpPr>
        <p:spPr>
          <a:xfrm>
            <a:off x="3655367" y="140125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5C26DFD-2F4D-B651-7A4D-4C08F495F697}"/>
              </a:ext>
            </a:extLst>
          </p:cNvPr>
          <p:cNvSpPr/>
          <p:nvPr/>
        </p:nvSpPr>
        <p:spPr>
          <a:xfrm>
            <a:off x="5621456" y="1370265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1B7C894C-692F-693B-22AF-FB88B1941A38}"/>
              </a:ext>
            </a:extLst>
          </p:cNvPr>
          <p:cNvSpPr/>
          <p:nvPr/>
        </p:nvSpPr>
        <p:spPr>
          <a:xfrm>
            <a:off x="1047305" y="1387122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C63EEBFD-8D20-BA33-5729-449A9B808902}"/>
              </a:ext>
            </a:extLst>
          </p:cNvPr>
          <p:cNvCxnSpPr>
            <a:cxnSpLocks/>
          </p:cNvCxnSpPr>
          <p:nvPr/>
        </p:nvCxnSpPr>
        <p:spPr>
          <a:xfrm>
            <a:off x="1214897" y="1865058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26A12EEA-E6A0-5C74-6D39-ED850B5020F2}"/>
              </a:ext>
            </a:extLst>
          </p:cNvPr>
          <p:cNvSpPr txBox="1"/>
          <p:nvPr/>
        </p:nvSpPr>
        <p:spPr>
          <a:xfrm>
            <a:off x="298171" y="3414416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26190A0-C4B4-246D-F76C-9BB4212D330C}"/>
              </a:ext>
            </a:extLst>
          </p:cNvPr>
          <p:cNvSpPr txBox="1"/>
          <p:nvPr/>
        </p:nvSpPr>
        <p:spPr>
          <a:xfrm>
            <a:off x="298171" y="298840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2047F2C7-DBDC-DE00-FFDD-330DBB671BFD}"/>
              </a:ext>
            </a:extLst>
          </p:cNvPr>
          <p:cNvSpPr/>
          <p:nvPr/>
        </p:nvSpPr>
        <p:spPr>
          <a:xfrm>
            <a:off x="2220416" y="1181816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ACC7A4E8-2D27-B808-58C9-86ECF566C68B}"/>
              </a:ext>
            </a:extLst>
          </p:cNvPr>
          <p:cNvSpPr/>
          <p:nvPr/>
        </p:nvSpPr>
        <p:spPr>
          <a:xfrm>
            <a:off x="2710347" y="1238216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0DCF1645-7FA4-35CB-37D5-7D4FFEB78D08}"/>
              </a:ext>
            </a:extLst>
          </p:cNvPr>
          <p:cNvSpPr/>
          <p:nvPr/>
        </p:nvSpPr>
        <p:spPr>
          <a:xfrm>
            <a:off x="3228338" y="129331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1A603920-E52C-9B2E-8579-384825AEF02B}"/>
              </a:ext>
            </a:extLst>
          </p:cNvPr>
          <p:cNvSpPr/>
          <p:nvPr/>
        </p:nvSpPr>
        <p:spPr>
          <a:xfrm>
            <a:off x="3772091" y="129879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CBF59B8-A9DF-97A8-29BC-29E2897AB263}"/>
              </a:ext>
            </a:extLst>
          </p:cNvPr>
          <p:cNvSpPr/>
          <p:nvPr/>
        </p:nvSpPr>
        <p:spPr>
          <a:xfrm>
            <a:off x="4298527" y="1326383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09B3F333-D717-4DEE-F1FB-CE9825392DCC}"/>
              </a:ext>
            </a:extLst>
          </p:cNvPr>
          <p:cNvSpPr/>
          <p:nvPr/>
        </p:nvSpPr>
        <p:spPr>
          <a:xfrm>
            <a:off x="1718126" y="1196235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BFD43D0-9849-0BBE-3C4D-902CBD0BA70A}"/>
              </a:ext>
            </a:extLst>
          </p:cNvPr>
          <p:cNvSpPr txBox="1"/>
          <p:nvPr/>
        </p:nvSpPr>
        <p:spPr>
          <a:xfrm>
            <a:off x="319996" y="281580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FFFA458A-3C81-66B1-03EC-0BFF30410976}"/>
              </a:ext>
            </a:extLst>
          </p:cNvPr>
          <p:cNvSpPr/>
          <p:nvPr/>
        </p:nvSpPr>
        <p:spPr>
          <a:xfrm>
            <a:off x="1883594" y="1220295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                     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331C7E4-FE9B-CC6B-8C8E-7E3374EEE0F4}"/>
              </a:ext>
            </a:extLst>
          </p:cNvPr>
          <p:cNvSpPr txBox="1"/>
          <p:nvPr/>
        </p:nvSpPr>
        <p:spPr>
          <a:xfrm>
            <a:off x="791763" y="1945535"/>
            <a:ext cx="449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N   C   N    C   N   C    N    C   N    C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11249AAC-93C6-AE00-64A5-A97E1175CE4E}"/>
              </a:ext>
            </a:extLst>
          </p:cNvPr>
          <p:cNvCxnSpPr>
            <a:cxnSpLocks/>
          </p:cNvCxnSpPr>
          <p:nvPr/>
        </p:nvCxnSpPr>
        <p:spPr>
          <a:xfrm>
            <a:off x="1170138" y="1486048"/>
            <a:ext cx="4360014" cy="1609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E2406C7B-C11C-30B0-5CEF-7D7529614551}"/>
              </a:ext>
            </a:extLst>
          </p:cNvPr>
          <p:cNvSpPr/>
          <p:nvPr/>
        </p:nvSpPr>
        <p:spPr>
          <a:xfrm flipH="1">
            <a:off x="2729234" y="669868"/>
            <a:ext cx="60584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EF2553AD-727A-1F05-B00E-042F82ACACBE}"/>
              </a:ext>
            </a:extLst>
          </p:cNvPr>
          <p:cNvSpPr/>
          <p:nvPr/>
        </p:nvSpPr>
        <p:spPr>
          <a:xfrm>
            <a:off x="2615894" y="1621048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ED2053DD-0453-1BAB-3807-F7A69B2E5187}"/>
              </a:ext>
            </a:extLst>
          </p:cNvPr>
          <p:cNvSpPr/>
          <p:nvPr/>
        </p:nvSpPr>
        <p:spPr>
          <a:xfrm>
            <a:off x="3138561" y="1632187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CAA4AEB4-3853-F502-9045-5B6A540D35C0}"/>
              </a:ext>
            </a:extLst>
          </p:cNvPr>
          <p:cNvSpPr/>
          <p:nvPr/>
        </p:nvSpPr>
        <p:spPr>
          <a:xfrm>
            <a:off x="3618515" y="1518999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F89977EA-FA44-225C-EDCD-9AA6A8BB20D2}"/>
              </a:ext>
            </a:extLst>
          </p:cNvPr>
          <p:cNvSpPr/>
          <p:nvPr/>
        </p:nvSpPr>
        <p:spPr>
          <a:xfrm>
            <a:off x="4141422" y="1504493"/>
            <a:ext cx="82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99BC2955-C3C9-8CF7-3112-A8B190A1E81A}"/>
              </a:ext>
            </a:extLst>
          </p:cNvPr>
          <p:cNvSpPr/>
          <p:nvPr/>
        </p:nvSpPr>
        <p:spPr>
          <a:xfrm>
            <a:off x="1587279" y="1612751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endParaRPr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888B518F-348B-5803-F854-75378E42CC32}"/>
              </a:ext>
            </a:extLst>
          </p:cNvPr>
          <p:cNvSpPr/>
          <p:nvPr/>
        </p:nvSpPr>
        <p:spPr>
          <a:xfrm>
            <a:off x="2130861" y="1618004"/>
            <a:ext cx="82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endParaRPr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4844F0C3-6A5A-69D9-1440-363ABE8B7DBE}"/>
              </a:ext>
            </a:extLst>
          </p:cNvPr>
          <p:cNvSpPr/>
          <p:nvPr/>
        </p:nvSpPr>
        <p:spPr>
          <a:xfrm>
            <a:off x="1057948" y="3171093"/>
            <a:ext cx="3795738" cy="26230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4BFF00F2-58D1-4641-7FC2-D1ABD213ACFA}"/>
              </a:ext>
            </a:extLst>
          </p:cNvPr>
          <p:cNvSpPr/>
          <p:nvPr/>
        </p:nvSpPr>
        <p:spPr>
          <a:xfrm>
            <a:off x="1125389" y="3931613"/>
            <a:ext cx="3795738" cy="26230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41F322D-5585-1924-E7AF-1387BDD7FAC0}"/>
              </a:ext>
            </a:extLst>
          </p:cNvPr>
          <p:cNvSpPr txBox="1"/>
          <p:nvPr/>
        </p:nvSpPr>
        <p:spPr>
          <a:xfrm>
            <a:off x="4893242" y="3960169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59E2AD0-081C-821E-F0C3-DA92A637ABA3}"/>
              </a:ext>
            </a:extLst>
          </p:cNvPr>
          <p:cNvSpPr txBox="1"/>
          <p:nvPr/>
        </p:nvSpPr>
        <p:spPr>
          <a:xfrm>
            <a:off x="4846688" y="3184951"/>
            <a:ext cx="1310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85C36EB-FC5A-9FDF-9759-4C3F6FBF1E50}"/>
              </a:ext>
            </a:extLst>
          </p:cNvPr>
          <p:cNvSpPr txBox="1"/>
          <p:nvPr/>
        </p:nvSpPr>
        <p:spPr>
          <a:xfrm>
            <a:off x="298171" y="3193438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8F0E06E-A67C-7981-5DFD-669C603D62DC}"/>
              </a:ext>
            </a:extLst>
          </p:cNvPr>
          <p:cNvSpPr txBox="1"/>
          <p:nvPr/>
        </p:nvSpPr>
        <p:spPr>
          <a:xfrm>
            <a:off x="298171" y="3888359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57A3A37-EAED-10E9-6C33-9C3183537811}"/>
              </a:ext>
            </a:extLst>
          </p:cNvPr>
          <p:cNvSpPr txBox="1"/>
          <p:nvPr/>
        </p:nvSpPr>
        <p:spPr>
          <a:xfrm>
            <a:off x="286145" y="2522174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A70D089-3697-CCA7-039F-4AD96869EF2E}"/>
              </a:ext>
            </a:extLst>
          </p:cNvPr>
          <p:cNvSpPr txBox="1"/>
          <p:nvPr/>
        </p:nvSpPr>
        <p:spPr>
          <a:xfrm>
            <a:off x="268335" y="2375345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7EACBE2-6A61-3FA4-97BD-DF140BF01A50}"/>
              </a:ext>
            </a:extLst>
          </p:cNvPr>
          <p:cNvSpPr txBox="1"/>
          <p:nvPr/>
        </p:nvSpPr>
        <p:spPr>
          <a:xfrm>
            <a:off x="263035" y="2200565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0CE1E6AD-E2C0-C4F4-9E71-C2F73019C358}"/>
              </a:ext>
            </a:extLst>
          </p:cNvPr>
          <p:cNvSpPr/>
          <p:nvPr/>
        </p:nvSpPr>
        <p:spPr>
          <a:xfrm>
            <a:off x="6130724" y="2498281"/>
            <a:ext cx="4279285" cy="42809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71F56BF-967F-D71B-8D5D-15CC98675C07}"/>
              </a:ext>
            </a:extLst>
          </p:cNvPr>
          <p:cNvSpPr txBox="1"/>
          <p:nvPr/>
        </p:nvSpPr>
        <p:spPr>
          <a:xfrm>
            <a:off x="10525349" y="2621151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1774A11-4BBF-651A-BDC0-C55F610D21B7}"/>
              </a:ext>
            </a:extLst>
          </p:cNvPr>
          <p:cNvSpPr txBox="1"/>
          <p:nvPr/>
        </p:nvSpPr>
        <p:spPr>
          <a:xfrm>
            <a:off x="336952" y="427867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  <a:endParaRPr dirty="0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9203A740-DF42-AFE8-C669-C3637993C2BC}"/>
              </a:ext>
            </a:extLst>
          </p:cNvPr>
          <p:cNvSpPr/>
          <p:nvPr/>
        </p:nvSpPr>
        <p:spPr>
          <a:xfrm>
            <a:off x="7754526" y="1403990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0EBA9DB9-9654-6BB0-3F59-C287C1BEEBC4}"/>
              </a:ext>
            </a:extLst>
          </p:cNvPr>
          <p:cNvSpPr/>
          <p:nvPr/>
        </p:nvSpPr>
        <p:spPr>
          <a:xfrm>
            <a:off x="9099255" y="141812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1FA1C35B-51E6-0A63-EF31-B54AEE26A758}"/>
              </a:ext>
            </a:extLst>
          </p:cNvPr>
          <p:cNvSpPr/>
          <p:nvPr/>
        </p:nvSpPr>
        <p:spPr>
          <a:xfrm>
            <a:off x="11065344" y="1387133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88B70F22-31BA-1E10-60EF-352FD6518829}"/>
              </a:ext>
            </a:extLst>
          </p:cNvPr>
          <p:cNvSpPr/>
          <p:nvPr/>
        </p:nvSpPr>
        <p:spPr>
          <a:xfrm>
            <a:off x="6491193" y="1403990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A8933648-AC63-00D6-B00B-EDF1AEFB11FB}"/>
              </a:ext>
            </a:extLst>
          </p:cNvPr>
          <p:cNvCxnSpPr>
            <a:cxnSpLocks/>
          </p:cNvCxnSpPr>
          <p:nvPr/>
        </p:nvCxnSpPr>
        <p:spPr>
          <a:xfrm>
            <a:off x="6658785" y="1881926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Rectangle 60">
            <a:extLst>
              <a:ext uri="{FF2B5EF4-FFF2-40B4-BE49-F238E27FC236}">
                <a16:creationId xmlns:a16="http://schemas.microsoft.com/office/drawing/2014/main" id="{56A59E4F-579F-2DA1-F381-548733995623}"/>
              </a:ext>
            </a:extLst>
          </p:cNvPr>
          <p:cNvSpPr/>
          <p:nvPr/>
        </p:nvSpPr>
        <p:spPr>
          <a:xfrm>
            <a:off x="7664304" y="1198684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47F1D5E7-0F40-58DB-AE6D-21C7434C266A}"/>
              </a:ext>
            </a:extLst>
          </p:cNvPr>
          <p:cNvSpPr/>
          <p:nvPr/>
        </p:nvSpPr>
        <p:spPr>
          <a:xfrm>
            <a:off x="8154235" y="1255084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8FE06E5E-DBE5-9501-0BDA-F46C01281B40}"/>
              </a:ext>
            </a:extLst>
          </p:cNvPr>
          <p:cNvSpPr/>
          <p:nvPr/>
        </p:nvSpPr>
        <p:spPr>
          <a:xfrm>
            <a:off x="8672226" y="1310180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9B0025B9-B802-16CC-19BF-AF14169F2376}"/>
              </a:ext>
            </a:extLst>
          </p:cNvPr>
          <p:cNvSpPr/>
          <p:nvPr/>
        </p:nvSpPr>
        <p:spPr>
          <a:xfrm>
            <a:off x="9215979" y="1315660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35B70527-34CE-5865-6A64-496521099BAB}"/>
              </a:ext>
            </a:extLst>
          </p:cNvPr>
          <p:cNvSpPr/>
          <p:nvPr/>
        </p:nvSpPr>
        <p:spPr>
          <a:xfrm>
            <a:off x="9742415" y="1343251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23A20486-4C02-4E31-9679-8F28471845EE}"/>
              </a:ext>
            </a:extLst>
          </p:cNvPr>
          <p:cNvSpPr/>
          <p:nvPr/>
        </p:nvSpPr>
        <p:spPr>
          <a:xfrm>
            <a:off x="7162014" y="1213103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518CBAED-C696-AEF8-D59A-765B88343823}"/>
              </a:ext>
            </a:extLst>
          </p:cNvPr>
          <p:cNvSpPr/>
          <p:nvPr/>
        </p:nvSpPr>
        <p:spPr>
          <a:xfrm>
            <a:off x="7327482" y="1237163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                     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1139955-DE9A-4855-3CF2-7F52F9AA8759}"/>
              </a:ext>
            </a:extLst>
          </p:cNvPr>
          <p:cNvSpPr txBox="1"/>
          <p:nvPr/>
        </p:nvSpPr>
        <p:spPr>
          <a:xfrm>
            <a:off x="6235651" y="1962403"/>
            <a:ext cx="449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N   C   N    C   N   C    N    C   N    C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2891B45C-AFDE-36FF-3C1A-EC88D96C34C3}"/>
              </a:ext>
            </a:extLst>
          </p:cNvPr>
          <p:cNvCxnSpPr>
            <a:cxnSpLocks/>
          </p:cNvCxnSpPr>
          <p:nvPr/>
        </p:nvCxnSpPr>
        <p:spPr>
          <a:xfrm>
            <a:off x="6614026" y="1502916"/>
            <a:ext cx="4360014" cy="1609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tangle 70">
            <a:extLst>
              <a:ext uri="{FF2B5EF4-FFF2-40B4-BE49-F238E27FC236}">
                <a16:creationId xmlns:a16="http://schemas.microsoft.com/office/drawing/2014/main" id="{EEFD25E5-DF91-060B-DF89-16D424EBDB6B}"/>
              </a:ext>
            </a:extLst>
          </p:cNvPr>
          <p:cNvSpPr/>
          <p:nvPr/>
        </p:nvSpPr>
        <p:spPr>
          <a:xfrm flipH="1">
            <a:off x="8173122" y="686736"/>
            <a:ext cx="60584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EC65A601-7C3E-40A3-CA88-D45E62B52467}"/>
              </a:ext>
            </a:extLst>
          </p:cNvPr>
          <p:cNvSpPr/>
          <p:nvPr/>
        </p:nvSpPr>
        <p:spPr>
          <a:xfrm>
            <a:off x="8059782" y="1637916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C4566AEF-FAA1-CFA3-A64D-13C9610D4AED}"/>
              </a:ext>
            </a:extLst>
          </p:cNvPr>
          <p:cNvSpPr/>
          <p:nvPr/>
        </p:nvSpPr>
        <p:spPr>
          <a:xfrm>
            <a:off x="8582449" y="1649055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1203F49E-4DA5-5326-68E6-7DF46CB6EB70}"/>
              </a:ext>
            </a:extLst>
          </p:cNvPr>
          <p:cNvSpPr/>
          <p:nvPr/>
        </p:nvSpPr>
        <p:spPr>
          <a:xfrm>
            <a:off x="9062403" y="1535867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28FBF01B-1306-10C8-96D7-B9748336B0AE}"/>
              </a:ext>
            </a:extLst>
          </p:cNvPr>
          <p:cNvSpPr/>
          <p:nvPr/>
        </p:nvSpPr>
        <p:spPr>
          <a:xfrm>
            <a:off x="9585310" y="1521361"/>
            <a:ext cx="82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1D875266-C5ED-5FF0-01DA-BDB358F4A33B}"/>
              </a:ext>
            </a:extLst>
          </p:cNvPr>
          <p:cNvSpPr/>
          <p:nvPr/>
        </p:nvSpPr>
        <p:spPr>
          <a:xfrm>
            <a:off x="7031167" y="1629619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endParaRPr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DE26BFE2-C852-7600-1A6B-EFFD80DE2975}"/>
              </a:ext>
            </a:extLst>
          </p:cNvPr>
          <p:cNvSpPr/>
          <p:nvPr/>
        </p:nvSpPr>
        <p:spPr>
          <a:xfrm>
            <a:off x="7574749" y="1634872"/>
            <a:ext cx="82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endParaRPr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14448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1" grpId="0"/>
      <p:bldP spid="43" grpId="0"/>
      <p:bldP spid="52" grpId="0"/>
      <p:bldP spid="69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243</Words>
  <Application>Microsoft Macintosh PowerPoint</Application>
  <PresentationFormat>Widescreen</PresentationFormat>
  <Paragraphs>15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2</cp:revision>
  <dcterms:created xsi:type="dcterms:W3CDTF">2024-05-17T07:57:37Z</dcterms:created>
  <dcterms:modified xsi:type="dcterms:W3CDTF">2024-05-17T09:23:33Z</dcterms:modified>
</cp:coreProperties>
</file>